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9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 userDrawn="1">
          <p15:clr>
            <a:srgbClr val="A4A3A4"/>
          </p15:clr>
        </p15:guide>
        <p15:guide id="2" pos="2160" userDrawn="1">
          <p15:clr>
            <a:srgbClr val="A4A3A4"/>
          </p15:clr>
        </p15:guide>
        <p15:guide id="3" orient="horz" pos="1436" userDrawn="1">
          <p15:clr>
            <a:srgbClr val="A4A3A4"/>
          </p15:clr>
        </p15:guide>
        <p15:guide id="4" orient="horz" pos="4407" userDrawn="1">
          <p15:clr>
            <a:srgbClr val="A4A3A4"/>
          </p15:clr>
        </p15:guide>
        <p15:guide id="5" orient="horz" pos="5677" userDrawn="1">
          <p15:clr>
            <a:srgbClr val="A4A3A4"/>
          </p15:clr>
        </p15:guide>
        <p15:guide id="6" pos="504" userDrawn="1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93568552-42BF-41B2-A50E-B7B6266727A2}" name="Mireille Vankemmelbeke" initials="MV" userId="S::MireilleVankemmelbeke@scancell.co.uk::e2496c92-8ae2-4817-81db-1e2fdf7923b3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50" d="100"/>
          <a:sy n="50" d="100"/>
        </p:scale>
        <p:origin x="2690" y="34"/>
      </p:cViewPr>
      <p:guideLst>
        <p:guide orient="horz" pos="3840"/>
        <p:guide pos="2160"/>
        <p:guide orient="horz" pos="1436"/>
        <p:guide orient="horz" pos="4407"/>
        <p:guide orient="horz" pos="5677"/>
        <p:guide pos="50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8/10/relationships/authors" Target="author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Mireille Vankemmelbeke" userId="e2496c92-8ae2-4817-81db-1e2fdf7923b3" providerId="ADAL" clId="{49D31B14-3643-4467-B6F3-5DC346F4EB42}"/>
    <pc:docChg chg="custSel delSld modSld">
      <pc:chgData name="Mireille Vankemmelbeke" userId="e2496c92-8ae2-4817-81db-1e2fdf7923b3" providerId="ADAL" clId="{49D31B14-3643-4467-B6F3-5DC346F4EB42}" dt="2024-06-21T15:46:00.648" v="4" actId="47"/>
      <pc:docMkLst>
        <pc:docMk/>
      </pc:docMkLst>
      <pc:sldChg chg="del">
        <pc:chgData name="Mireille Vankemmelbeke" userId="e2496c92-8ae2-4817-81db-1e2fdf7923b3" providerId="ADAL" clId="{49D31B14-3643-4467-B6F3-5DC346F4EB42}" dt="2024-06-21T15:45:45.840" v="0" actId="47"/>
        <pc:sldMkLst>
          <pc:docMk/>
          <pc:sldMk cId="3935331238" sldId="268"/>
        </pc:sldMkLst>
      </pc:sldChg>
      <pc:sldChg chg="delSp modSp mod">
        <pc:chgData name="Mireille Vankemmelbeke" userId="e2496c92-8ae2-4817-81db-1e2fdf7923b3" providerId="ADAL" clId="{49D31B14-3643-4467-B6F3-5DC346F4EB42}" dt="2024-06-21T15:45:59.566" v="3" actId="478"/>
        <pc:sldMkLst>
          <pc:docMk/>
          <pc:sldMk cId="868960993" sldId="269"/>
        </pc:sldMkLst>
        <pc:spChg chg="del">
          <ac:chgData name="Mireille Vankemmelbeke" userId="e2496c92-8ae2-4817-81db-1e2fdf7923b3" providerId="ADAL" clId="{49D31B14-3643-4467-B6F3-5DC346F4EB42}" dt="2024-06-21T15:45:51.749" v="1" actId="478"/>
          <ac:spMkLst>
            <pc:docMk/>
            <pc:sldMk cId="868960993" sldId="269"/>
            <ac:spMk id="4" creationId="{5E3CACEE-8BE5-F31F-E9D6-FEF2DBE2523D}"/>
          </ac:spMkLst>
        </pc:spChg>
        <pc:spChg chg="del">
          <ac:chgData name="Mireille Vankemmelbeke" userId="e2496c92-8ae2-4817-81db-1e2fdf7923b3" providerId="ADAL" clId="{49D31B14-3643-4467-B6F3-5DC346F4EB42}" dt="2024-06-21T15:45:51.749" v="1" actId="478"/>
          <ac:spMkLst>
            <pc:docMk/>
            <pc:sldMk cId="868960993" sldId="269"/>
            <ac:spMk id="7" creationId="{83275967-3BAD-8453-FBF6-8E47B83E5243}"/>
          </ac:spMkLst>
        </pc:spChg>
        <pc:spChg chg="mod">
          <ac:chgData name="Mireille Vankemmelbeke" userId="e2496c92-8ae2-4817-81db-1e2fdf7923b3" providerId="ADAL" clId="{49D31B14-3643-4467-B6F3-5DC346F4EB42}" dt="2024-06-21T15:45:57.456" v="2" actId="1076"/>
          <ac:spMkLst>
            <pc:docMk/>
            <pc:sldMk cId="868960993" sldId="269"/>
            <ac:spMk id="9" creationId="{A86364A3-3171-51B5-56DC-97814CC6E14F}"/>
          </ac:spMkLst>
        </pc:spChg>
        <pc:spChg chg="del">
          <ac:chgData name="Mireille Vankemmelbeke" userId="e2496c92-8ae2-4817-81db-1e2fdf7923b3" providerId="ADAL" clId="{49D31B14-3643-4467-B6F3-5DC346F4EB42}" dt="2024-06-21T15:45:59.566" v="3" actId="478"/>
          <ac:spMkLst>
            <pc:docMk/>
            <pc:sldMk cId="868960993" sldId="269"/>
            <ac:spMk id="10" creationId="{A6EE4B9E-931A-D0B8-45E9-DDDDD02F55DB}"/>
          </ac:spMkLst>
        </pc:spChg>
        <pc:spChg chg="del">
          <ac:chgData name="Mireille Vankemmelbeke" userId="e2496c92-8ae2-4817-81db-1e2fdf7923b3" providerId="ADAL" clId="{49D31B14-3643-4467-B6F3-5DC346F4EB42}" dt="2024-06-21T15:45:51.749" v="1" actId="478"/>
          <ac:spMkLst>
            <pc:docMk/>
            <pc:sldMk cId="868960993" sldId="269"/>
            <ac:spMk id="14" creationId="{C0AD6B4A-FDED-1CF3-8BBF-3C89DC9125F8}"/>
          </ac:spMkLst>
        </pc:spChg>
        <pc:spChg chg="del">
          <ac:chgData name="Mireille Vankemmelbeke" userId="e2496c92-8ae2-4817-81db-1e2fdf7923b3" providerId="ADAL" clId="{49D31B14-3643-4467-B6F3-5DC346F4EB42}" dt="2024-06-21T15:45:51.749" v="1" actId="478"/>
          <ac:spMkLst>
            <pc:docMk/>
            <pc:sldMk cId="868960993" sldId="269"/>
            <ac:spMk id="15" creationId="{AAA63D9A-720A-38FA-30FE-B64A03B0D307}"/>
          </ac:spMkLst>
        </pc:spChg>
        <pc:picChg chg="del">
          <ac:chgData name="Mireille Vankemmelbeke" userId="e2496c92-8ae2-4817-81db-1e2fdf7923b3" providerId="ADAL" clId="{49D31B14-3643-4467-B6F3-5DC346F4EB42}" dt="2024-06-21T15:45:51.749" v="1" actId="478"/>
          <ac:picMkLst>
            <pc:docMk/>
            <pc:sldMk cId="868960993" sldId="269"/>
            <ac:picMk id="3" creationId="{07C6B656-125D-EBDD-6A94-0B7A000C716B}"/>
          </ac:picMkLst>
        </pc:picChg>
        <pc:picChg chg="del">
          <ac:chgData name="Mireille Vankemmelbeke" userId="e2496c92-8ae2-4817-81db-1e2fdf7923b3" providerId="ADAL" clId="{49D31B14-3643-4467-B6F3-5DC346F4EB42}" dt="2024-06-21T15:45:51.749" v="1" actId="478"/>
          <ac:picMkLst>
            <pc:docMk/>
            <pc:sldMk cId="868960993" sldId="269"/>
            <ac:picMk id="11" creationId="{1B83C6A4-C081-437D-17C4-D1FA03343D30}"/>
          </ac:picMkLst>
        </pc:picChg>
        <pc:picChg chg="del">
          <ac:chgData name="Mireille Vankemmelbeke" userId="e2496c92-8ae2-4817-81db-1e2fdf7923b3" providerId="ADAL" clId="{49D31B14-3643-4467-B6F3-5DC346F4EB42}" dt="2024-06-21T15:45:59.566" v="3" actId="478"/>
          <ac:picMkLst>
            <pc:docMk/>
            <pc:sldMk cId="868960993" sldId="269"/>
            <ac:picMk id="16" creationId="{436ACC07-BBAC-908B-678D-4EE4BA15215E}"/>
          </ac:picMkLst>
        </pc:picChg>
        <pc:picChg chg="mod">
          <ac:chgData name="Mireille Vankemmelbeke" userId="e2496c92-8ae2-4817-81db-1e2fdf7923b3" providerId="ADAL" clId="{49D31B14-3643-4467-B6F3-5DC346F4EB42}" dt="2024-06-21T15:45:57.456" v="2" actId="1076"/>
          <ac:picMkLst>
            <pc:docMk/>
            <pc:sldMk cId="868960993" sldId="269"/>
            <ac:picMk id="17" creationId="{BD10C5BA-FE39-7C16-D7AC-4A4000C9580F}"/>
          </ac:picMkLst>
        </pc:picChg>
        <pc:picChg chg="del">
          <ac:chgData name="Mireille Vankemmelbeke" userId="e2496c92-8ae2-4817-81db-1e2fdf7923b3" providerId="ADAL" clId="{49D31B14-3643-4467-B6F3-5DC346F4EB42}" dt="2024-06-21T15:45:51.749" v="1" actId="478"/>
          <ac:picMkLst>
            <pc:docMk/>
            <pc:sldMk cId="868960993" sldId="269"/>
            <ac:picMk id="19" creationId="{56993332-3CBE-EF21-6E05-DD9C043541F3}"/>
          </ac:picMkLst>
        </pc:picChg>
      </pc:sldChg>
      <pc:sldChg chg="del">
        <pc:chgData name="Mireille Vankemmelbeke" userId="e2496c92-8ae2-4817-81db-1e2fdf7923b3" providerId="ADAL" clId="{49D31B14-3643-4467-B6F3-5DC346F4EB42}" dt="2024-06-21T15:46:00.648" v="4" actId="47"/>
        <pc:sldMkLst>
          <pc:docMk/>
          <pc:sldMk cId="2268793920" sldId="270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07ED1A2-C795-4A89-BC5A-004D576CF3DF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A34F97C-AF6A-4678-A188-E641391358E4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631473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40817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34315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97030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19088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463236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98543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87447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95993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70211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536878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984850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B2FAE3E-4C77-4744-B238-740C31CDFDF5}" type="datetimeFigureOut">
              <a:rPr lang="en-GB" smtClean="0"/>
              <a:t>21/06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49D7D79-9823-4E93-9662-95E1F1FBC1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156388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1">
            <a:extLst>
              <a:ext uri="{FF2B5EF4-FFF2-40B4-BE49-F238E27FC236}">
                <a16:creationId xmlns:a16="http://schemas.microsoft.com/office/drawing/2014/main" id="{A86364A3-3171-51B5-56DC-97814CC6E14F}"/>
              </a:ext>
            </a:extLst>
          </p:cNvPr>
          <p:cNvSpPr txBox="1"/>
          <p:nvPr/>
        </p:nvSpPr>
        <p:spPr>
          <a:xfrm>
            <a:off x="70451" y="1965102"/>
            <a:ext cx="6656138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GB" sz="900" b="1"/>
              <a:t>Supplemental Figure 7</a:t>
            </a:r>
            <a:r>
              <a:rPr lang="en-GB" sz="900"/>
              <a:t>. Serum levels of SC134-TCB and B12-TCB in non-tumour bearing NSG mice detected for up to 144 hours, after a single dose (100</a:t>
            </a:r>
            <a:r>
              <a:rPr lang="en-GB" sz="900">
                <a:sym typeface="Symbol" panose="05050102010706020507" pitchFamily="18" charset="2"/>
              </a:rPr>
              <a:t></a:t>
            </a:r>
            <a:r>
              <a:rPr lang="en-GB" sz="900"/>
              <a:t>g). </a:t>
            </a:r>
          </a:p>
        </p:txBody>
      </p:sp>
      <p:sp>
        <p:nvSpPr>
          <p:cNvPr id="13" name="Title 1">
            <a:extLst>
              <a:ext uri="{FF2B5EF4-FFF2-40B4-BE49-F238E27FC236}">
                <a16:creationId xmlns:a16="http://schemas.microsoft.com/office/drawing/2014/main" id="{6625F3AB-E145-5FC1-46A0-49170BFF6139}"/>
              </a:ext>
            </a:extLst>
          </p:cNvPr>
          <p:cNvSpPr txBox="1">
            <a:spLocks/>
          </p:cNvSpPr>
          <p:nvPr/>
        </p:nvSpPr>
        <p:spPr>
          <a:xfrm>
            <a:off x="30481" y="1107112"/>
            <a:ext cx="5604510" cy="10645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GB" sz="2400" dirty="0"/>
              <a:t>Supplemental Figures</a:t>
            </a:r>
            <a:endParaRPr lang="en-GB" sz="1100" dirty="0"/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BD10C5BA-FE39-7C16-D7AC-4A4000C9580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15977" r="536"/>
          <a:stretch/>
        </p:blipFill>
        <p:spPr>
          <a:xfrm>
            <a:off x="682754" y="2406540"/>
            <a:ext cx="2582839" cy="144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689609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3</Words>
  <Application>Microsoft Office PowerPoint</Application>
  <PresentationFormat>Widescreen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reille Vankemmelbeke</dc:creator>
  <cp:lastModifiedBy>Mireille Vankemmelbeke</cp:lastModifiedBy>
  <cp:revision>3</cp:revision>
  <dcterms:created xsi:type="dcterms:W3CDTF">2024-03-08T14:10:38Z</dcterms:created>
  <dcterms:modified xsi:type="dcterms:W3CDTF">2024-06-21T15:46:04Z</dcterms:modified>
</cp:coreProperties>
</file>